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75" d="100"/>
          <a:sy n="75" d="100"/>
        </p:scale>
        <p:origin x="1500" y="-29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E4909-E09D-4445-A97B-A183C5A00022}" type="datetimeFigureOut">
              <a:rPr lang="es-AR" smtClean="0"/>
              <a:t>23/5/2025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26B8B-EF50-490E-96B6-A16EA1341BF8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361717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E4909-E09D-4445-A97B-A183C5A00022}" type="datetimeFigureOut">
              <a:rPr lang="es-AR" smtClean="0"/>
              <a:t>23/5/2025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26B8B-EF50-490E-96B6-A16EA1341BF8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711179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E4909-E09D-4445-A97B-A183C5A00022}" type="datetimeFigureOut">
              <a:rPr lang="es-AR" smtClean="0"/>
              <a:t>23/5/2025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26B8B-EF50-490E-96B6-A16EA1341BF8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42673012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E4909-E09D-4445-A97B-A183C5A00022}" type="datetimeFigureOut">
              <a:rPr lang="es-AR" smtClean="0"/>
              <a:t>23/5/2025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26B8B-EF50-490E-96B6-A16EA1341BF8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9887524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E4909-E09D-4445-A97B-A183C5A00022}" type="datetimeFigureOut">
              <a:rPr lang="es-AR" smtClean="0"/>
              <a:t>23/5/2025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26B8B-EF50-490E-96B6-A16EA1341BF8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0141935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E4909-E09D-4445-A97B-A183C5A00022}" type="datetimeFigureOut">
              <a:rPr lang="es-AR" smtClean="0"/>
              <a:t>23/5/2025</a:t>
            </a:fld>
            <a:endParaRPr lang="es-A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26B8B-EF50-490E-96B6-A16EA1341BF8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676356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E4909-E09D-4445-A97B-A183C5A00022}" type="datetimeFigureOut">
              <a:rPr lang="es-AR" smtClean="0"/>
              <a:t>23/5/2025</a:t>
            </a:fld>
            <a:endParaRPr lang="es-A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26B8B-EF50-490E-96B6-A16EA1341BF8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8701660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E4909-E09D-4445-A97B-A183C5A00022}" type="datetimeFigureOut">
              <a:rPr lang="es-AR" smtClean="0"/>
              <a:t>23/5/2025</a:t>
            </a:fld>
            <a:endParaRPr lang="es-A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26B8B-EF50-490E-96B6-A16EA1341BF8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41760991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E4909-E09D-4445-A97B-A183C5A00022}" type="datetimeFigureOut">
              <a:rPr lang="es-AR" smtClean="0"/>
              <a:t>23/5/2025</a:t>
            </a:fld>
            <a:endParaRPr lang="es-A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26B8B-EF50-490E-96B6-A16EA1341BF8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991187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E4909-E09D-4445-A97B-A183C5A00022}" type="datetimeFigureOut">
              <a:rPr lang="es-AR" smtClean="0"/>
              <a:t>23/5/2025</a:t>
            </a:fld>
            <a:endParaRPr lang="es-A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26B8B-EF50-490E-96B6-A16EA1341BF8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8418047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E4909-E09D-4445-A97B-A183C5A00022}" type="datetimeFigureOut">
              <a:rPr lang="es-AR" smtClean="0"/>
              <a:t>23/5/2025</a:t>
            </a:fld>
            <a:endParaRPr lang="es-A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26B8B-EF50-490E-96B6-A16EA1341BF8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5725013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EE4909-E09D-4445-A97B-A183C5A00022}" type="datetimeFigureOut">
              <a:rPr lang="es-AR" smtClean="0"/>
              <a:t>23/5/2025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E26B8B-EF50-490E-96B6-A16EA1341BF8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6758220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sv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Imagen 1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3314" y="3372125"/>
            <a:ext cx="1691998" cy="5447749"/>
          </a:xfrm>
          <a:prstGeom prst="rect">
            <a:avLst/>
          </a:prstGeom>
        </p:spPr>
      </p:pic>
      <p:sp>
        <p:nvSpPr>
          <p:cNvPr id="18" name="CuadroTexto 17"/>
          <p:cNvSpPr txBox="1"/>
          <p:nvPr/>
        </p:nvSpPr>
        <p:spPr>
          <a:xfrm>
            <a:off x="3574302" y="310993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19" name="CuadroTexto 18"/>
          <p:cNvSpPr txBox="1"/>
          <p:nvPr/>
        </p:nvSpPr>
        <p:spPr>
          <a:xfrm>
            <a:off x="1313312" y="310993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200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pic>
        <p:nvPicPr>
          <p:cNvPr id="23" name="Imagen 2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74304" y="3372123"/>
            <a:ext cx="1804892" cy="5779854"/>
          </a:xfrm>
          <a:prstGeom prst="rect">
            <a:avLst/>
          </a:prstGeom>
        </p:spPr>
      </p:pic>
      <p:pic>
        <p:nvPicPr>
          <p:cNvPr id="12" name="Gráfico 11">
            <a:extLst>
              <a:ext uri="{FF2B5EF4-FFF2-40B4-BE49-F238E27FC236}">
                <a16:creationId xmlns:a16="http://schemas.microsoft.com/office/drawing/2014/main" id="{AE32F40F-794D-CC9D-D3B6-A1F2A4E0A16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334176" y="6627601"/>
            <a:ext cx="1084224" cy="919763"/>
          </a:xfrm>
          <a:prstGeom prst="rect">
            <a:avLst/>
          </a:prstGeom>
        </p:spPr>
      </p:pic>
      <p:pic>
        <p:nvPicPr>
          <p:cNvPr id="4" name="Gráfico 3">
            <a:extLst>
              <a:ext uri="{FF2B5EF4-FFF2-40B4-BE49-F238E27FC236}">
                <a16:creationId xmlns:a16="http://schemas.microsoft.com/office/drawing/2014/main" id="{D5652214-7DFF-471D-9A8D-5C1BC2F28FF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3743579" y="6627601"/>
            <a:ext cx="982284" cy="1219187"/>
          </a:xfrm>
          <a:prstGeom prst="rect">
            <a:avLst/>
          </a:prstGeom>
        </p:spPr>
      </p:pic>
      <p:sp>
        <p:nvSpPr>
          <p:cNvPr id="10" name="Rectángulo 9">
            <a:extLst>
              <a:ext uri="{FF2B5EF4-FFF2-40B4-BE49-F238E27FC236}">
                <a16:creationId xmlns:a16="http://schemas.microsoft.com/office/drawing/2014/main" id="{A51AB76A-51C0-E4F0-3803-6E201515ECD2}"/>
              </a:ext>
            </a:extLst>
          </p:cNvPr>
          <p:cNvSpPr>
            <a:spLocks noGrp="1" noRot="1" noMove="1" noResize="1" noEditPoints="1" noAdjustHandles="1" noChangeArrowheads="1" noChangeShapeType="1"/>
          </p:cNvSpPr>
          <p:nvPr/>
        </p:nvSpPr>
        <p:spPr>
          <a:xfrm>
            <a:off x="3098800" y="3337165"/>
            <a:ext cx="130175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436BAAA7-7AC2-B2E8-F97D-F65D766218A9}"/>
              </a:ext>
            </a:extLst>
          </p:cNvPr>
          <p:cNvSpPr txBox="1"/>
          <p:nvPr/>
        </p:nvSpPr>
        <p:spPr>
          <a:xfrm>
            <a:off x="328232" y="9195200"/>
            <a:ext cx="6201536" cy="191045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000" b="1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Fig. S3: Phylogenomic trees of selected isolates</a:t>
            </a:r>
            <a:r>
              <a:rPr lang="en-US" sz="1000" b="1" i="1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</a:t>
            </a:r>
            <a:r>
              <a:rPr lang="en-US" sz="1000" b="1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and related strains.</a:t>
            </a:r>
            <a:r>
              <a:rPr lang="en-US" sz="1000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Phylogenetic history of the strains were inferred using A) 208 common orthologous genes among the 129 genomes available from the </a:t>
            </a:r>
            <a:r>
              <a:rPr lang="en-US" sz="1000" i="1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B. </a:t>
            </a:r>
            <a:r>
              <a:rPr lang="en-US" sz="1000" i="1" dirty="0" err="1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amyloliquefaciens</a:t>
            </a:r>
            <a:r>
              <a:rPr lang="en-US" sz="1000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group and </a:t>
            </a:r>
            <a:r>
              <a:rPr lang="en-US" sz="1000" i="1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B. subtilis</a:t>
            </a:r>
            <a:r>
              <a:rPr lang="en-US" sz="1000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168 strain as outgroup; and </a:t>
            </a:r>
            <a:r>
              <a:rPr lang="en-US" sz="1000" dirty="0">
                <a:latin typeface="Arial" panose="020B0604020202020204" pitchFamily="34" charset="0"/>
                <a:ea typeface="SimSun" panose="02010600030101010101" pitchFamily="2" charset="-122"/>
              </a:rPr>
              <a:t>B</a:t>
            </a:r>
            <a:r>
              <a:rPr lang="en-US" sz="1000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) 216 common orthologous genes among the 126 available genomes of the </a:t>
            </a:r>
            <a:r>
              <a:rPr lang="en-US" sz="1000" i="1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P. megaterium</a:t>
            </a:r>
            <a:r>
              <a:rPr lang="en-US" sz="1000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group and </a:t>
            </a:r>
            <a:r>
              <a:rPr lang="en-US" sz="1000" i="1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Bacillus</a:t>
            </a:r>
            <a:r>
              <a:rPr lang="en-US" sz="1000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sp. PHB10. In all cases, the genes were individually aligned and concatenated. Trees were constructed with </a:t>
            </a:r>
            <a:r>
              <a:rPr lang="en-US" sz="1000" dirty="0" err="1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RAxML</a:t>
            </a:r>
            <a:r>
              <a:rPr lang="en-US" sz="1000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algorithm (Stamatakis 2014) and displayed and annotated using </a:t>
            </a:r>
            <a:r>
              <a:rPr lang="en-US" sz="1000" dirty="0" err="1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iTOL</a:t>
            </a:r>
            <a:r>
              <a:rPr lang="en-US" sz="1000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(</a:t>
            </a:r>
            <a:r>
              <a:rPr lang="en-US" sz="1000" dirty="0" err="1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Letunic</a:t>
            </a:r>
            <a:r>
              <a:rPr lang="en-US" sz="1000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and Bork 2011). The inferred tree reliabilities were evaluated by bootstrapping with </a:t>
            </a:r>
            <a:r>
              <a:rPr lang="en-US" sz="100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100 replicates. </a:t>
            </a:r>
            <a:r>
              <a:rPr lang="en-US" sz="1000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The strains corresponding to the selected isolates are highlighted in grey and the type strains shown in bold letters.</a:t>
            </a:r>
            <a:endParaRPr lang="es-AR" sz="1000" dirty="0">
              <a:effectLst/>
              <a:latin typeface="Arial" panose="020B0604020202020204" pitchFamily="34" charset="0"/>
              <a:ea typeface="SimSun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4993294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Tema de 2022">
  <a:themeElements>
    <a:clrScheme name="Office 2013 - Tema de 2022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Tema de 2022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Tema de 2022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37</TotalTime>
  <Words>141</Words>
  <Application>Microsoft Office PowerPoint</Application>
  <PresentationFormat>Panorámica</PresentationFormat>
  <Paragraphs>3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2013 - Tema de 2022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espariz</dc:creator>
  <cp:lastModifiedBy>Martin Espariz</cp:lastModifiedBy>
  <cp:revision>11</cp:revision>
  <dcterms:created xsi:type="dcterms:W3CDTF">2020-10-28T15:17:12Z</dcterms:created>
  <dcterms:modified xsi:type="dcterms:W3CDTF">2025-05-23T18:47:41Z</dcterms:modified>
</cp:coreProperties>
</file>